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1" d="100"/>
          <a:sy n="131" d="100"/>
        </p:scale>
        <p:origin x="-140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686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38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874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264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674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374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482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40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5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039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6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7E2F6-84AE-49F5-BBAE-240B3A2B28F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7856A-04DF-416D-AF82-9A19B2D4EA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83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354" y="347993"/>
            <a:ext cx="1600199" cy="1198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0043" y="2910063"/>
            <a:ext cx="1576388" cy="800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76200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6612" y="1414905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6612" y="2057400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2601" y="729105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9737" y="1034679"/>
            <a:ext cx="1457325" cy="10989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7863" y="1855826"/>
            <a:ext cx="1457325" cy="11159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799" y="5486400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7863" y="5241521"/>
            <a:ext cx="1457325" cy="11159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5" name="Elbow Connector 4"/>
          <p:cNvCxnSpPr>
            <a:stCxn id="1027" idx="3"/>
            <a:endCxn id="1026" idx="0"/>
          </p:cNvCxnSpPr>
          <p:nvPr/>
        </p:nvCxnSpPr>
        <p:spPr>
          <a:xfrm>
            <a:off x="4505325" y="511748"/>
            <a:ext cx="1632912" cy="2398315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Elbow Connector 14"/>
          <p:cNvCxnSpPr>
            <a:stCxn id="8" idx="3"/>
            <a:endCxn id="1026" idx="0"/>
          </p:cNvCxnSpPr>
          <p:nvPr/>
        </p:nvCxnSpPr>
        <p:spPr>
          <a:xfrm>
            <a:off x="4525126" y="1164653"/>
            <a:ext cx="1613111" cy="174541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Elbow Connector 18"/>
          <p:cNvCxnSpPr>
            <a:stCxn id="6" idx="3"/>
            <a:endCxn id="1026" idx="0"/>
          </p:cNvCxnSpPr>
          <p:nvPr/>
        </p:nvCxnSpPr>
        <p:spPr>
          <a:xfrm>
            <a:off x="4529137" y="1850453"/>
            <a:ext cx="1609100" cy="105961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Elbow Connector 19"/>
          <p:cNvCxnSpPr>
            <a:stCxn id="7" idx="3"/>
            <a:endCxn id="1026" idx="0"/>
          </p:cNvCxnSpPr>
          <p:nvPr/>
        </p:nvCxnSpPr>
        <p:spPr>
          <a:xfrm>
            <a:off x="4529137" y="2492948"/>
            <a:ext cx="1609100" cy="417115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Elbow Connector 28"/>
          <p:cNvCxnSpPr>
            <a:stCxn id="1028" idx="1"/>
          </p:cNvCxnSpPr>
          <p:nvPr/>
        </p:nvCxnSpPr>
        <p:spPr>
          <a:xfrm rot="10800000" flipV="1">
            <a:off x="6138237" y="1584139"/>
            <a:ext cx="1381501" cy="1542995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Elbow Connector 31"/>
          <p:cNvCxnSpPr>
            <a:stCxn id="10" idx="1"/>
            <a:endCxn id="1026" idx="0"/>
          </p:cNvCxnSpPr>
          <p:nvPr/>
        </p:nvCxnSpPr>
        <p:spPr>
          <a:xfrm rot="10800000" flipV="1">
            <a:off x="6138237" y="2413813"/>
            <a:ext cx="1429626" cy="49625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Elbow Connector 39"/>
          <p:cNvCxnSpPr>
            <a:stCxn id="11" idx="3"/>
            <a:endCxn id="1026" idx="2"/>
          </p:cNvCxnSpPr>
          <p:nvPr/>
        </p:nvCxnSpPr>
        <p:spPr>
          <a:xfrm flipV="1">
            <a:off x="4505324" y="3710768"/>
            <a:ext cx="1632913" cy="221118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Elbow Connector 42"/>
          <p:cNvCxnSpPr>
            <a:stCxn id="12" idx="1"/>
            <a:endCxn id="1026" idx="2"/>
          </p:cNvCxnSpPr>
          <p:nvPr/>
        </p:nvCxnSpPr>
        <p:spPr>
          <a:xfrm rot="10800000">
            <a:off x="6138237" y="3710768"/>
            <a:ext cx="1429626" cy="208874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343400" y="5102423"/>
            <a:ext cx="387692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an be expanded to fit any quantity of computers</a:t>
            </a:r>
            <a:endParaRPr lang="en-US" sz="14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09337" y="1192065"/>
            <a:ext cx="246246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Inbound HTTP</a:t>
            </a:r>
            <a:br>
              <a:rPr lang="en-US" sz="1200" b="1" dirty="0" smtClean="0"/>
            </a:br>
            <a:r>
              <a:rPr lang="en-US" sz="1200" b="1" dirty="0" smtClean="0"/>
              <a:t>Outbound HTTP, HTTPS, FTP, SMTP</a:t>
            </a:r>
            <a:endParaRPr lang="en-US" sz="12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4572000" y="875127"/>
            <a:ext cx="12954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ead Node</a:t>
            </a:r>
            <a:endParaRPr lang="en-US" sz="12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572000" y="1447800"/>
            <a:ext cx="12954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ompute node</a:t>
            </a:r>
            <a:endParaRPr lang="en-US" sz="12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572000" y="2209800"/>
            <a:ext cx="13716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ompute node</a:t>
            </a:r>
            <a:endParaRPr lang="en-US" sz="1200" b="1" dirty="0"/>
          </a:p>
        </p:txBody>
      </p:sp>
      <p:cxnSp>
        <p:nvCxnSpPr>
          <p:cNvPr id="46" name="Elbow Connector 45"/>
          <p:cNvCxnSpPr>
            <a:stCxn id="1027" idx="1"/>
            <a:endCxn id="1029" idx="3"/>
          </p:cNvCxnSpPr>
          <p:nvPr/>
        </p:nvCxnSpPr>
        <p:spPr>
          <a:xfrm rot="10800000" flipV="1">
            <a:off x="2210554" y="511747"/>
            <a:ext cx="1142247" cy="435547"/>
          </a:xfrm>
          <a:prstGeom prst="bentConnector3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572000" y="196478"/>
            <a:ext cx="98107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 smtClean="0"/>
              <a:t>Web server(s)</a:t>
            </a:r>
            <a:endParaRPr lang="en-US" sz="1050" b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903" y="2527558"/>
            <a:ext cx="1943100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54" name="Straight Connector 53"/>
          <p:cNvCxnSpPr>
            <a:stCxn id="1029" idx="2"/>
            <a:endCxn id="1030" idx="0"/>
          </p:cNvCxnSpPr>
          <p:nvPr/>
        </p:nvCxnSpPr>
        <p:spPr>
          <a:xfrm flipH="1">
            <a:off x="1410453" y="1546597"/>
            <a:ext cx="1" cy="9809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48" y="4497587"/>
            <a:ext cx="249555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3" name="Elbow Connector 62"/>
          <p:cNvCxnSpPr>
            <a:stCxn id="1030" idx="2"/>
            <a:endCxn id="1031" idx="0"/>
          </p:cNvCxnSpPr>
          <p:nvPr/>
        </p:nvCxnSpPr>
        <p:spPr>
          <a:xfrm rot="5400000">
            <a:off x="1152286" y="4239420"/>
            <a:ext cx="512704" cy="3630"/>
          </a:xfrm>
          <a:prstGeom prst="bentConnector3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572000" y="5590401"/>
            <a:ext cx="12954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ompute node</a:t>
            </a:r>
            <a:endParaRPr lang="en-US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6781800" y="1295400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NAS</a:t>
            </a:r>
            <a:endParaRPr lang="en-US" sz="12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6781800" y="2057400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NAS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6858000" y="5514201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NAS</a:t>
            </a:r>
            <a:endParaRPr lang="en-US" sz="1200" b="1" dirty="0"/>
          </a:p>
        </p:txBody>
      </p:sp>
      <p:sp>
        <p:nvSpPr>
          <p:cNvPr id="2" name="Rectangle 1"/>
          <p:cNvSpPr/>
          <p:nvPr/>
        </p:nvSpPr>
        <p:spPr>
          <a:xfrm>
            <a:off x="5715300" y="3581400"/>
            <a:ext cx="84587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InfiniBand</a:t>
            </a:r>
            <a:endParaRPr lang="en-US" sz="12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118884" y="6109900"/>
            <a:ext cx="72314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Users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932554" y="3605539"/>
            <a:ext cx="1725046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HIVE</a:t>
            </a:r>
            <a:br>
              <a:rPr lang="en-US" sz="2400" b="1" dirty="0" smtClean="0"/>
            </a:br>
            <a:r>
              <a:rPr lang="en-US" sz="2400" b="1" dirty="0" smtClean="0"/>
              <a:t>architecture</a:t>
            </a:r>
            <a:endParaRPr lang="en-US" sz="24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8123964" y="3061552"/>
            <a:ext cx="314075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 smtClean="0"/>
              <a:t>.</a:t>
            </a:r>
            <a:br>
              <a:rPr lang="en-US" b="1" dirty="0" smtClean="0"/>
            </a:br>
            <a:r>
              <a:rPr lang="en-US" b="1" dirty="0" smtClean="0"/>
              <a:t>.</a:t>
            </a:r>
            <a:br>
              <a:rPr lang="en-US" b="1" dirty="0" smtClean="0"/>
            </a:br>
            <a:r>
              <a:rPr lang="en-US" b="1" dirty="0" smtClean="0"/>
              <a:t>.</a:t>
            </a:r>
            <a:endParaRPr 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3795836" y="2972756"/>
            <a:ext cx="314075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 smtClean="0"/>
              <a:t>.</a:t>
            </a:r>
            <a:br>
              <a:rPr lang="en-US" b="1" dirty="0" smtClean="0"/>
            </a:br>
            <a:r>
              <a:rPr lang="en-US" b="1" dirty="0" smtClean="0"/>
              <a:t>.</a:t>
            </a:r>
            <a:br>
              <a:rPr lang="en-US" b="1" dirty="0" smtClean="0"/>
            </a:br>
            <a:r>
              <a:rPr lang="en-US" b="1" dirty="0" smtClean="0"/>
              <a:t>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1928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354" y="782596"/>
            <a:ext cx="1600199" cy="1198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8812" y="4241235"/>
            <a:ext cx="1576388" cy="800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5657" y="1219200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7600" y="5455292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3800" y="5455292"/>
            <a:ext cx="1152525" cy="871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5675" y="1093826"/>
            <a:ext cx="1457325" cy="11159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4" name="Elbow Connector 13"/>
          <p:cNvCxnSpPr>
            <a:stCxn id="6" idx="3"/>
            <a:endCxn id="5" idx="0"/>
          </p:cNvCxnSpPr>
          <p:nvPr/>
        </p:nvCxnSpPr>
        <p:spPr>
          <a:xfrm>
            <a:off x="4868182" y="1654748"/>
            <a:ext cx="1658824" cy="2586487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lbow Connector 16"/>
          <p:cNvCxnSpPr>
            <a:stCxn id="8" idx="1"/>
            <a:endCxn id="5" idx="2"/>
          </p:cNvCxnSpPr>
          <p:nvPr/>
        </p:nvCxnSpPr>
        <p:spPr>
          <a:xfrm rot="10800000">
            <a:off x="6527006" y="5041940"/>
            <a:ext cx="940594" cy="84890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Elbow Connector 19"/>
          <p:cNvCxnSpPr>
            <a:stCxn id="12" idx="3"/>
            <a:endCxn id="5" idx="2"/>
          </p:cNvCxnSpPr>
          <p:nvPr/>
        </p:nvCxnSpPr>
        <p:spPr>
          <a:xfrm flipV="1">
            <a:off x="4886325" y="5041940"/>
            <a:ext cx="1640681" cy="848900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Elbow Connector 20"/>
          <p:cNvCxnSpPr>
            <a:stCxn id="13" idx="1"/>
            <a:endCxn id="5" idx="0"/>
          </p:cNvCxnSpPr>
          <p:nvPr/>
        </p:nvCxnSpPr>
        <p:spPr>
          <a:xfrm rot="10800000" flipV="1">
            <a:off x="6527007" y="1651813"/>
            <a:ext cx="778669" cy="2589422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09337" y="1519535"/>
            <a:ext cx="246246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Inbound HTTP</a:t>
            </a:r>
            <a:br>
              <a:rPr lang="en-US" sz="1200" b="1" dirty="0" smtClean="0"/>
            </a:br>
            <a:r>
              <a:rPr lang="en-US" sz="1200" b="1" dirty="0" smtClean="0"/>
              <a:t>Outbound HTTP, HTTPS, FTP, SMTP</a:t>
            </a:r>
            <a:endParaRPr lang="en-US" sz="12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5487871" y="6049388"/>
            <a:ext cx="12571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ompute </a:t>
            </a:r>
            <a:r>
              <a:rPr lang="en-US" sz="1200" b="1" dirty="0" smtClean="0"/>
              <a:t>nodes</a:t>
            </a:r>
            <a:endParaRPr lang="en-US" sz="1200" b="1" dirty="0"/>
          </a:p>
        </p:txBody>
      </p:sp>
      <p:cxnSp>
        <p:nvCxnSpPr>
          <p:cNvPr id="27" name="Elbow Connector 26"/>
          <p:cNvCxnSpPr>
            <a:stCxn id="6" idx="1"/>
            <a:endCxn id="4" idx="3"/>
          </p:cNvCxnSpPr>
          <p:nvPr/>
        </p:nvCxnSpPr>
        <p:spPr>
          <a:xfrm rot="10800000">
            <a:off x="2210553" y="1381898"/>
            <a:ext cx="1505104" cy="272850"/>
          </a:xfrm>
          <a:prstGeom prst="bentConnector3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415619" y="1259728"/>
            <a:ext cx="1752599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Web </a:t>
            </a:r>
            <a:r>
              <a:rPr lang="en-US" sz="1050" b="1" dirty="0" smtClean="0"/>
              <a:t>server</a:t>
            </a:r>
            <a:r>
              <a:rPr lang="en-US" sz="1050" b="1" dirty="0" smtClean="0"/>
              <a:t> / Head node 1U</a:t>
            </a:r>
          </a:p>
        </p:txBody>
      </p:sp>
      <p:pic>
        <p:nvPicPr>
          <p:cNvPr id="29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903" y="2527558"/>
            <a:ext cx="1943100" cy="145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0" name="Straight Connector 29"/>
          <p:cNvCxnSpPr>
            <a:stCxn id="4" idx="2"/>
            <a:endCxn id="29" idx="0"/>
          </p:cNvCxnSpPr>
          <p:nvPr/>
        </p:nvCxnSpPr>
        <p:spPr>
          <a:xfrm flipH="1">
            <a:off x="1410453" y="1981200"/>
            <a:ext cx="1" cy="546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48" y="4497587"/>
            <a:ext cx="249555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2" name="Elbow Connector 31"/>
          <p:cNvCxnSpPr>
            <a:stCxn id="29" idx="2"/>
            <a:endCxn id="31" idx="0"/>
          </p:cNvCxnSpPr>
          <p:nvPr/>
        </p:nvCxnSpPr>
        <p:spPr>
          <a:xfrm rot="5400000">
            <a:off x="1152286" y="4239420"/>
            <a:ext cx="512704" cy="3630"/>
          </a:xfrm>
          <a:prstGeom prst="bentConnector3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6096000" y="3964236"/>
            <a:ext cx="84587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Network</a:t>
            </a:r>
            <a:endParaRPr lang="en-US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1118884" y="6109900"/>
            <a:ext cx="72314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User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946400" y="2636143"/>
            <a:ext cx="249184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 smtClean="0"/>
              <a:t>ColonialOne</a:t>
            </a:r>
            <a:r>
              <a:rPr lang="en-US" sz="1600" b="1" dirty="0" smtClean="0"/>
              <a:t> implementation</a:t>
            </a:r>
            <a:endParaRPr lang="en-US" sz="1600" b="1" dirty="0"/>
          </a:p>
        </p:txBody>
      </p:sp>
      <p:sp>
        <p:nvSpPr>
          <p:cNvPr id="102" name="Oval Callout 101"/>
          <p:cNvSpPr/>
          <p:nvPr/>
        </p:nvSpPr>
        <p:spPr>
          <a:xfrm>
            <a:off x="941041" y="401596"/>
            <a:ext cx="1078832" cy="685800"/>
          </a:xfrm>
          <a:prstGeom prst="wedgeEllipseCallout">
            <a:avLst>
              <a:gd name="adj1" fmla="val 1622"/>
              <a:gd name="adj2" fmla="val 73461"/>
            </a:avLst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700" b="1" dirty="0" smtClean="0"/>
              <a:t>Is Web Server protected by a firewall?</a:t>
            </a:r>
            <a:endParaRPr lang="en-US" sz="700" b="1" dirty="0"/>
          </a:p>
        </p:txBody>
      </p:sp>
      <p:sp>
        <p:nvSpPr>
          <p:cNvPr id="103" name="Oval Callout 102"/>
          <p:cNvSpPr/>
          <p:nvPr/>
        </p:nvSpPr>
        <p:spPr>
          <a:xfrm>
            <a:off x="2876203" y="402502"/>
            <a:ext cx="1078832" cy="685800"/>
          </a:xfrm>
          <a:prstGeom prst="wedgeEllipseCallout">
            <a:avLst>
              <a:gd name="adj1" fmla="val -37394"/>
              <a:gd name="adj2" fmla="val 92509"/>
            </a:avLst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700" b="1" dirty="0" smtClean="0"/>
              <a:t>Outbound connection speed? Traffic?</a:t>
            </a:r>
            <a:endParaRPr lang="en-US" sz="700" b="1" dirty="0"/>
          </a:p>
        </p:txBody>
      </p:sp>
      <p:sp>
        <p:nvSpPr>
          <p:cNvPr id="104" name="Oval Callout 103"/>
          <p:cNvSpPr/>
          <p:nvPr/>
        </p:nvSpPr>
        <p:spPr>
          <a:xfrm>
            <a:off x="4424865" y="482972"/>
            <a:ext cx="1769272" cy="486762"/>
          </a:xfrm>
          <a:prstGeom prst="wedgeEllipseCallout">
            <a:avLst>
              <a:gd name="adj1" fmla="val 21655"/>
              <a:gd name="adj2" fmla="val 179363"/>
            </a:avLst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700" b="1" dirty="0" smtClean="0"/>
              <a:t>10Gbps is maximum here or </a:t>
            </a:r>
            <a:r>
              <a:rPr lang="en-US" sz="700" b="1" dirty="0" err="1" smtClean="0"/>
              <a:t>Infiniband</a:t>
            </a:r>
            <a:r>
              <a:rPr lang="en-US" sz="700" b="1" dirty="0" smtClean="0"/>
              <a:t> is possible?</a:t>
            </a:r>
            <a:endParaRPr lang="en-US" sz="700" b="1" dirty="0"/>
          </a:p>
        </p:txBody>
      </p:sp>
      <p:sp>
        <p:nvSpPr>
          <p:cNvPr id="105" name="Oval Callout 104"/>
          <p:cNvSpPr/>
          <p:nvPr/>
        </p:nvSpPr>
        <p:spPr>
          <a:xfrm>
            <a:off x="6945502" y="482972"/>
            <a:ext cx="1769272" cy="486762"/>
          </a:xfrm>
          <a:prstGeom prst="wedgeEllipseCallout">
            <a:avLst>
              <a:gd name="adj1" fmla="val -52586"/>
              <a:gd name="adj2" fmla="val 173399"/>
            </a:avLst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700" b="1" dirty="0" smtClean="0"/>
              <a:t>Is NAS connected to compute cluster by </a:t>
            </a:r>
            <a:r>
              <a:rPr lang="en-US" sz="700" b="1" dirty="0" err="1" smtClean="0"/>
              <a:t>Infiniband</a:t>
            </a:r>
            <a:r>
              <a:rPr lang="en-US" sz="700" b="1" dirty="0" smtClean="0"/>
              <a:t>?</a:t>
            </a:r>
            <a:endParaRPr lang="en-US" sz="700" b="1" dirty="0"/>
          </a:p>
        </p:txBody>
      </p:sp>
      <p:sp>
        <p:nvSpPr>
          <p:cNvPr id="106" name="TextBox 105"/>
          <p:cNvSpPr txBox="1"/>
          <p:nvPr/>
        </p:nvSpPr>
        <p:spPr>
          <a:xfrm>
            <a:off x="7239000" y="1905000"/>
            <a:ext cx="1600200" cy="50013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/>
              <a:t>NAS</a:t>
            </a:r>
            <a:br>
              <a:rPr lang="en-US" sz="1050" b="1" dirty="0" smtClean="0"/>
            </a:br>
            <a:r>
              <a:rPr lang="en-US" sz="800" b="1" dirty="0" smtClean="0"/>
              <a:t>mounted </a:t>
            </a:r>
            <a:r>
              <a:rPr lang="en-US" sz="800" b="1" dirty="0"/>
              <a:t>on all compute nodes and web </a:t>
            </a:r>
            <a:r>
              <a:rPr lang="en-US" sz="800" b="1" dirty="0" smtClean="0"/>
              <a:t>server</a:t>
            </a:r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782639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77</Words>
  <Application>Microsoft Office PowerPoint</Application>
  <PresentationFormat>On-screen Show (4:3)</PresentationFormat>
  <Paragraphs>2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F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</dc:creator>
  <cp:lastModifiedBy>Anton Golikov</cp:lastModifiedBy>
  <cp:revision>18</cp:revision>
  <dcterms:created xsi:type="dcterms:W3CDTF">2013-12-23T19:56:15Z</dcterms:created>
  <dcterms:modified xsi:type="dcterms:W3CDTF">2014-10-23T14:30:49Z</dcterms:modified>
</cp:coreProperties>
</file>